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8"/>
  </p:notesMasterIdLst>
  <p:sldIdLst>
    <p:sldId id="256" r:id="rId2"/>
    <p:sldId id="259" r:id="rId3"/>
    <p:sldId id="273" r:id="rId4"/>
    <p:sldId id="260" r:id="rId5"/>
    <p:sldId id="258" r:id="rId6"/>
    <p:sldId id="257" r:id="rId7"/>
  </p:sldIdLst>
  <p:sldSz cx="6858000" cy="9906000" type="A4"/>
  <p:notesSz cx="6889750" cy="100218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092" autoAdjust="0"/>
    <p:restoredTop sz="94660"/>
  </p:normalViewPr>
  <p:slideViewPr>
    <p:cSldViewPr snapToGrid="0" showGuides="1">
      <p:cViewPr varScale="1">
        <p:scale>
          <a:sx n="73" d="100"/>
          <a:sy n="73" d="100"/>
        </p:scale>
        <p:origin x="3684" y="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902597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r">
              <a:defRPr sz="1300"/>
            </a:lvl1pPr>
          </a:lstStyle>
          <a:p>
            <a:fld id="{A910879C-4E20-4371-82C0-D8259C76862A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4888" y="1252538"/>
            <a:ext cx="2339975" cy="33829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34" tIns="48317" rIns="96634" bIns="48317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8975" y="4823034"/>
            <a:ext cx="5511800" cy="3946118"/>
          </a:xfrm>
          <a:prstGeom prst="rect">
            <a:avLst/>
          </a:prstGeom>
        </p:spPr>
        <p:txBody>
          <a:bodyPr vert="horz" lIns="96634" tIns="48317" rIns="96634" bIns="48317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902597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r">
              <a:defRPr sz="1300"/>
            </a:lvl1pPr>
          </a:lstStyle>
          <a:p>
            <a:fld id="{6D814C6F-0710-42F9-86F9-8E7B8E37031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40104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D814C6F-0710-42F9-86F9-8E7B8E370313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34253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D814C6F-0710-42F9-86F9-8E7B8E370313}" type="slidenum">
              <a:rPr lang="ko-KR" altLang="en-US" smtClean="0"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529115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B0700-1318-41D8-995A-DE74AA1AE07B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94F24-152A-4A8A-8F2F-A19E5EE043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9802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B0700-1318-41D8-995A-DE74AA1AE07B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94F24-152A-4A8A-8F2F-A19E5EE043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19294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B0700-1318-41D8-995A-DE74AA1AE07B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94F24-152A-4A8A-8F2F-A19E5EE043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60362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B0700-1318-41D8-995A-DE74AA1AE07B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94F24-152A-4A8A-8F2F-A19E5EE043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8189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B0700-1318-41D8-995A-DE74AA1AE07B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94F24-152A-4A8A-8F2F-A19E5EE043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53907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B0700-1318-41D8-995A-DE74AA1AE07B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94F24-152A-4A8A-8F2F-A19E5EE043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476846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B0700-1318-41D8-995A-DE74AA1AE07B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94F24-152A-4A8A-8F2F-A19E5EE043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6592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B0700-1318-41D8-995A-DE74AA1AE07B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94F24-152A-4A8A-8F2F-A19E5EE043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82290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B0700-1318-41D8-995A-DE74AA1AE07B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94F24-152A-4A8A-8F2F-A19E5EE043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7893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B0700-1318-41D8-995A-DE74AA1AE07B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94F24-152A-4A8A-8F2F-A19E5EE043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8465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B0700-1318-41D8-995A-DE74AA1AE07B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94F24-152A-4A8A-8F2F-A19E5EE043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19162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8B0700-1318-41D8-995A-DE74AA1AE07B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394F24-152A-4A8A-8F2F-A19E5EE043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2619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Relationship Id="rId9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altLang="ko-KR" sz="2800" b="1" dirty="0" smtClean="0"/>
              <a:t>Supplementary figures</a:t>
            </a:r>
            <a:endParaRPr lang="ko-KR" altLang="en-US" sz="2800" b="1" dirty="0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52460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표 2"/>
          <p:cNvGraphicFramePr>
            <a:graphicFrameLocks noGrp="1" noChangeAspect="1"/>
          </p:cNvGraphicFramePr>
          <p:nvPr>
            <p:extLst/>
          </p:nvPr>
        </p:nvGraphicFramePr>
        <p:xfrm>
          <a:off x="39757" y="1113314"/>
          <a:ext cx="6767947" cy="8175239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986317">
                  <a:extLst>
                    <a:ext uri="{9D8B030D-6E8A-4147-A177-3AD203B41FA5}">
                      <a16:colId xmlns:a16="http://schemas.microsoft.com/office/drawing/2014/main" val="818774147"/>
                    </a:ext>
                  </a:extLst>
                </a:gridCol>
                <a:gridCol w="2890815">
                  <a:extLst>
                    <a:ext uri="{9D8B030D-6E8A-4147-A177-3AD203B41FA5}">
                      <a16:colId xmlns:a16="http://schemas.microsoft.com/office/drawing/2014/main" val="487117252"/>
                    </a:ext>
                  </a:extLst>
                </a:gridCol>
                <a:gridCol w="2890815">
                  <a:extLst>
                    <a:ext uri="{9D8B030D-6E8A-4147-A177-3AD203B41FA5}">
                      <a16:colId xmlns:a16="http://schemas.microsoft.com/office/drawing/2014/main" val="1025303340"/>
                    </a:ext>
                  </a:extLst>
                </a:gridCol>
              </a:tblGrid>
              <a:tr h="39742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vironmental</a:t>
                      </a:r>
                      <a:r>
                        <a:rPr lang="en-US" altLang="ko-KR" sz="1100" b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actor</a:t>
                      </a:r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-</a:t>
                      </a:r>
                      <a:r>
                        <a:rPr lang="en-US" altLang="ko-KR" sz="1100" b="1" baseline="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ussianization</a:t>
                      </a:r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t-</a:t>
                      </a:r>
                      <a:r>
                        <a:rPr lang="en-US" altLang="ko-KR" sz="1100" b="1" baseline="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ussianization</a:t>
                      </a:r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42167355"/>
                  </a:ext>
                </a:extLst>
              </a:tr>
              <a:tr h="1111117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cohol</a:t>
                      </a:r>
                      <a:r>
                        <a:rPr lang="en-US" altLang="ko-KR" sz="1100" b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take frequency</a:t>
                      </a:r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47680407"/>
                  </a:ext>
                </a:extLst>
              </a:tr>
              <a:tr h="1111117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MI</a:t>
                      </a:r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46644489"/>
                  </a:ext>
                </a:extLst>
              </a:tr>
              <a:tr h="1111117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omnia</a:t>
                      </a:r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14509164"/>
                  </a:ext>
                </a:extLst>
              </a:tr>
              <a:tr h="1111117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 score</a:t>
                      </a:r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74149574"/>
                  </a:ext>
                </a:extLst>
              </a:tr>
              <a:tr h="1111117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roticism score</a:t>
                      </a:r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88495887"/>
                  </a:ext>
                </a:extLst>
              </a:tr>
              <a:tr h="1111117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me spent watching TV</a:t>
                      </a:r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35959863"/>
                  </a:ext>
                </a:extLst>
              </a:tr>
              <a:tr h="1111117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DI</a:t>
                      </a:r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93881126"/>
                  </a:ext>
                </a:extLst>
              </a:tr>
            </a:tbl>
          </a:graphicData>
        </a:graphic>
      </p:graphicFrame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2"/>
          <a:srcRect b="11481"/>
          <a:stretch/>
        </p:blipFill>
        <p:spPr>
          <a:xfrm>
            <a:off x="1157260" y="1542787"/>
            <a:ext cx="2628000" cy="1042956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3"/>
          <a:srcRect b="10745"/>
          <a:stretch/>
        </p:blipFill>
        <p:spPr>
          <a:xfrm>
            <a:off x="4038006" y="1547580"/>
            <a:ext cx="2628000" cy="1042876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57260" y="2660830"/>
            <a:ext cx="2628000" cy="1037712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038006" y="2660145"/>
            <a:ext cx="2628000" cy="1042876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57260" y="3773629"/>
            <a:ext cx="2628000" cy="1042876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038006" y="3772710"/>
            <a:ext cx="2628000" cy="1042876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 rotWithShape="1">
          <a:blip r:embed="rId8"/>
          <a:srcRect b="10444"/>
          <a:stretch/>
        </p:blipFill>
        <p:spPr>
          <a:xfrm>
            <a:off x="1157260" y="4891592"/>
            <a:ext cx="2628000" cy="1042876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 rotWithShape="1">
          <a:blip r:embed="rId9"/>
          <a:srcRect b="11402"/>
          <a:stretch/>
        </p:blipFill>
        <p:spPr>
          <a:xfrm>
            <a:off x="4038006" y="4885275"/>
            <a:ext cx="2628000" cy="1042876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57260" y="6009555"/>
            <a:ext cx="2628000" cy="1042876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038006" y="5997840"/>
            <a:ext cx="2628000" cy="1042876"/>
          </a:xfrm>
          <a:prstGeom prst="rect">
            <a:avLst/>
          </a:prstGeom>
        </p:spPr>
      </p:pic>
      <p:pic>
        <p:nvPicPr>
          <p:cNvPr id="14" name="그림 13"/>
          <p:cNvPicPr>
            <a:picLocks noChangeAspect="1"/>
          </p:cNvPicPr>
          <p:nvPr/>
        </p:nvPicPr>
        <p:blipFill rotWithShape="1">
          <a:blip r:embed="rId12"/>
          <a:srcRect t="11490" b="10673"/>
          <a:stretch/>
        </p:blipFill>
        <p:spPr>
          <a:xfrm>
            <a:off x="1157260" y="7127519"/>
            <a:ext cx="2628000" cy="1020361"/>
          </a:xfrm>
          <a:prstGeom prst="rect">
            <a:avLst/>
          </a:prstGeom>
        </p:spPr>
      </p:pic>
      <p:pic>
        <p:nvPicPr>
          <p:cNvPr id="15" name="그림 14"/>
          <p:cNvPicPr>
            <a:picLocks noChangeAspect="1"/>
          </p:cNvPicPr>
          <p:nvPr/>
        </p:nvPicPr>
        <p:blipFill rotWithShape="1">
          <a:blip r:embed="rId13"/>
          <a:srcRect b="12074"/>
          <a:stretch/>
        </p:blipFill>
        <p:spPr>
          <a:xfrm>
            <a:off x="4038006" y="7110405"/>
            <a:ext cx="2628000" cy="1042876"/>
          </a:xfrm>
          <a:prstGeom prst="rect">
            <a:avLst/>
          </a:prstGeom>
        </p:spPr>
      </p:pic>
      <p:pic>
        <p:nvPicPr>
          <p:cNvPr id="16" name="그림 15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57260" y="8222967"/>
            <a:ext cx="2628000" cy="1042876"/>
          </a:xfrm>
          <a:prstGeom prst="rect">
            <a:avLst/>
          </a:prstGeom>
        </p:spPr>
      </p:pic>
      <p:pic>
        <p:nvPicPr>
          <p:cNvPr id="17" name="그림 16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038006" y="8222969"/>
            <a:ext cx="2628000" cy="1042876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1" y="381000"/>
            <a:ext cx="7681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ko-KR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95056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1954969" y="1234753"/>
            <a:ext cx="1521000" cy="2925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87,409 samples genotyped</a:t>
            </a:r>
          </a:p>
        </p:txBody>
      </p:sp>
      <p:cxnSp>
        <p:nvCxnSpPr>
          <p:cNvPr id="3" name="직선 화살표 연결선 2"/>
          <p:cNvCxnSpPr>
            <a:stCxn id="2" idx="2"/>
            <a:endCxn id="5" idx="0"/>
          </p:cNvCxnSpPr>
          <p:nvPr/>
        </p:nvCxnSpPr>
        <p:spPr>
          <a:xfrm>
            <a:off x="2715469" y="1527253"/>
            <a:ext cx="0" cy="34202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1944391" y="1014356"/>
            <a:ext cx="1542156" cy="2299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9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UK Biobank resource</a:t>
            </a:r>
            <a:endParaRPr lang="ko-KR" altLang="en-US" sz="89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1954969" y="1869275"/>
            <a:ext cx="1521000" cy="2925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6,536 unrelated samples</a:t>
            </a:r>
          </a:p>
        </p:txBody>
      </p:sp>
      <p:sp>
        <p:nvSpPr>
          <p:cNvPr id="6" name="직사각형 5"/>
          <p:cNvSpPr/>
          <p:nvPr/>
        </p:nvSpPr>
        <p:spPr>
          <a:xfrm>
            <a:off x="1954969" y="2579865"/>
            <a:ext cx="1521000" cy="2925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91,567 unused samples</a:t>
            </a:r>
          </a:p>
        </p:txBody>
      </p:sp>
      <p:cxnSp>
        <p:nvCxnSpPr>
          <p:cNvPr id="7" name="직선 화살표 연결선 6"/>
          <p:cNvCxnSpPr>
            <a:stCxn id="5" idx="2"/>
            <a:endCxn id="6" idx="0"/>
          </p:cNvCxnSpPr>
          <p:nvPr/>
        </p:nvCxnSpPr>
        <p:spPr>
          <a:xfrm>
            <a:off x="2715469" y="2161775"/>
            <a:ext cx="0" cy="41809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직선 화살표 연결선 7"/>
          <p:cNvCxnSpPr>
            <a:stCxn id="6" idx="2"/>
            <a:endCxn id="10" idx="0"/>
          </p:cNvCxnSpPr>
          <p:nvPr/>
        </p:nvCxnSpPr>
        <p:spPr>
          <a:xfrm>
            <a:off x="2715469" y="2872365"/>
            <a:ext cx="0" cy="66308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직사각형 8"/>
          <p:cNvSpPr/>
          <p:nvPr/>
        </p:nvSpPr>
        <p:spPr>
          <a:xfrm>
            <a:off x="3531317" y="2724139"/>
            <a:ext cx="2252250" cy="108225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39303" indent="-139303">
              <a:buFont typeface="Arial" panose="020B0604020202020204" pitchFamily="34" charset="0"/>
              <a:buChar char="•"/>
            </a:pP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ctor diagnosed COPD (N = 1,163)</a:t>
            </a:r>
          </a:p>
          <a:p>
            <a:pPr marL="139303" indent="-139303">
              <a:buFont typeface="Arial" panose="020B0604020202020204" pitchFamily="34" charset="0"/>
              <a:buChar char="•"/>
            </a:pP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ssing smoking status (N = 1,264)</a:t>
            </a:r>
          </a:p>
          <a:p>
            <a:pPr marL="139303" indent="-139303">
              <a:buFont typeface="Arial" panose="020B0604020202020204" pitchFamily="34" charset="0"/>
              <a:buChar char="•"/>
            </a:pP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asthma developed &lt; 16 years (N = 1,429)</a:t>
            </a:r>
          </a:p>
          <a:p>
            <a:pPr marL="139303" indent="-139303">
              <a:buFont typeface="Arial" panose="020B0604020202020204" pitchFamily="34" charset="0"/>
              <a:buChar char="•"/>
            </a:pP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 samples with blood clot, emphysema, chronic bronchitis, hay fever, allergic rhinitis, or eczema (N = 83,010)</a:t>
            </a:r>
          </a:p>
        </p:txBody>
      </p:sp>
      <p:sp>
        <p:nvSpPr>
          <p:cNvPr id="10" name="직사각형 9"/>
          <p:cNvSpPr/>
          <p:nvPr/>
        </p:nvSpPr>
        <p:spPr>
          <a:xfrm>
            <a:off x="1954969" y="3535448"/>
            <a:ext cx="1521000" cy="585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4,701 samples</a:t>
            </a:r>
          </a:p>
          <a:p>
            <a:pPr algn="ctr"/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513 late-onset asthma vs.</a:t>
            </a:r>
          </a:p>
          <a:p>
            <a:pPr algn="ctr"/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4,188 controls)</a:t>
            </a:r>
          </a:p>
        </p:txBody>
      </p:sp>
      <p:sp>
        <p:nvSpPr>
          <p:cNvPr id="12" name="직사각형 11"/>
          <p:cNvSpPr/>
          <p:nvPr/>
        </p:nvSpPr>
        <p:spPr>
          <a:xfrm>
            <a:off x="3531317" y="2041294"/>
            <a:ext cx="2252250" cy="6435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39303" indent="-139303">
              <a:buFont typeface="Arial" panose="020B0604020202020204" pitchFamily="34" charset="0"/>
              <a:buChar char="•"/>
            </a:pP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sed samples in the discovery </a:t>
            </a:r>
            <a:r>
              <a:rPr lang="en-US" altLang="ko-KR" sz="894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×multiE</a:t>
            </a: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alysis (N = 153,795)</a:t>
            </a:r>
          </a:p>
          <a:p>
            <a:pPr marL="139303" indent="-139303">
              <a:buFont typeface="Arial" panose="020B0604020202020204" pitchFamily="34" charset="0"/>
              <a:buChar char="•"/>
            </a:pP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sed samples in the </a:t>
            </a:r>
            <a:r>
              <a:rPr lang="en-US" altLang="ko-KR" sz="894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×singleE</a:t>
            </a: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alysis (N = 11,174)</a:t>
            </a:r>
          </a:p>
        </p:txBody>
      </p:sp>
      <p:cxnSp>
        <p:nvCxnSpPr>
          <p:cNvPr id="14" name="직선 화살표 연결선 13"/>
          <p:cNvCxnSpPr>
            <a:stCxn id="10" idx="2"/>
            <a:endCxn id="15" idx="0"/>
          </p:cNvCxnSpPr>
          <p:nvPr/>
        </p:nvCxnSpPr>
        <p:spPr>
          <a:xfrm flipH="1">
            <a:off x="2710532" y="4120449"/>
            <a:ext cx="4938" cy="115079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직사각형 14"/>
          <p:cNvSpPr/>
          <p:nvPr/>
        </p:nvSpPr>
        <p:spPr>
          <a:xfrm>
            <a:off x="970156" y="5271238"/>
            <a:ext cx="3480750" cy="131625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894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×multiE</a:t>
            </a: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teraction test via </a:t>
            </a:r>
            <a:r>
              <a:rPr lang="en-US" altLang="ko-KR" sz="894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uctLMM</a:t>
            </a:r>
            <a:endParaRPr lang="en-US" altLang="ko-KR" sz="894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ko-KR" sz="894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39303" indent="-139303">
              <a:buFont typeface="Arial" panose="020B0604020202020204" pitchFamily="34" charset="0"/>
              <a:buChar char="•"/>
            </a:pP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s117996675 with alcohol intake frequency, BMI, MET score, and time spent watching TV (case = 379 / control = 57,542)</a:t>
            </a:r>
          </a:p>
          <a:p>
            <a:pPr marL="139303" indent="-139303">
              <a:buFont typeface="Arial" panose="020B0604020202020204" pitchFamily="34" charset="0"/>
              <a:buChar char="•"/>
            </a:pP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ko-KR" sz="894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345749 </a:t>
            </a: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ith alcohol intake frequency, BMI, insomnia, neuroticism score, and time spent watching TV (case = 395 / control = 57,422)</a:t>
            </a:r>
          </a:p>
          <a:p>
            <a:pPr marL="139303" indent="-139303">
              <a:buFont typeface="Arial" panose="020B0604020202020204" pitchFamily="34" charset="0"/>
              <a:buChar char="•"/>
            </a:pPr>
            <a:r>
              <a:rPr lang="en-US" altLang="ko-KR" sz="894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s17704680 </a:t>
            </a: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ith alcohol intake frequency, BMI, time spent watching TV, and TDI (case = 507 / control = 101,284)</a:t>
            </a:r>
          </a:p>
        </p:txBody>
      </p:sp>
      <p:sp>
        <p:nvSpPr>
          <p:cNvPr id="16" name="직사각형 15"/>
          <p:cNvSpPr/>
          <p:nvPr/>
        </p:nvSpPr>
        <p:spPr>
          <a:xfrm>
            <a:off x="3531317" y="3846159"/>
            <a:ext cx="2252250" cy="137475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amples with missing information for each environmental factor</a:t>
            </a:r>
          </a:p>
          <a:p>
            <a:pPr marL="139303" indent="-139303">
              <a:buFont typeface="Arial" panose="020B0604020202020204" pitchFamily="34" charset="0"/>
              <a:buChar char="•"/>
            </a:pP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cohol intake frequency  (N = 169)</a:t>
            </a:r>
          </a:p>
          <a:p>
            <a:pPr marL="139303" indent="-139303">
              <a:buFont typeface="Arial" panose="020B0604020202020204" pitchFamily="34" charset="0"/>
              <a:buChar char="•"/>
            </a:pP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MI  (N =  810)</a:t>
            </a:r>
          </a:p>
          <a:p>
            <a:pPr marL="139303" indent="-139303">
              <a:buFont typeface="Arial" panose="020B0604020202020204" pitchFamily="34" charset="0"/>
              <a:buChar char="•"/>
            </a:pP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somnia  (N = 158)</a:t>
            </a:r>
          </a:p>
          <a:p>
            <a:pPr marL="139303" indent="-139303">
              <a:buFont typeface="Arial" panose="020B0604020202020204" pitchFamily="34" charset="0"/>
              <a:buChar char="•"/>
            </a:pP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 score (N = 45,737)</a:t>
            </a:r>
          </a:p>
          <a:p>
            <a:pPr marL="139303" indent="-139303">
              <a:buFont typeface="Arial" panose="020B0604020202020204" pitchFamily="34" charset="0"/>
              <a:buChar char="•"/>
            </a:pP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uroticism score (N = 45,270)</a:t>
            </a:r>
          </a:p>
          <a:p>
            <a:pPr marL="139303" indent="-139303">
              <a:buFont typeface="Arial" panose="020B0604020202020204" pitchFamily="34" charset="0"/>
              <a:buChar char="•"/>
            </a:pP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ime spent watching TV  (N = 1,700)</a:t>
            </a:r>
          </a:p>
          <a:p>
            <a:pPr marL="139303" indent="-139303">
              <a:buFont typeface="Arial" panose="020B0604020202020204" pitchFamily="34" charset="0"/>
              <a:buChar char="•"/>
            </a:pP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DI (N = 280)</a:t>
            </a:r>
          </a:p>
        </p:txBody>
      </p:sp>
      <p:sp>
        <p:nvSpPr>
          <p:cNvPr id="18" name="직사각형 17"/>
          <p:cNvSpPr/>
          <p:nvPr/>
        </p:nvSpPr>
        <p:spPr>
          <a:xfrm>
            <a:off x="3531317" y="1362763"/>
            <a:ext cx="2252250" cy="6435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39303" indent="-139303">
              <a:buFont typeface="Arial" panose="020B0604020202020204" pitchFamily="34" charset="0"/>
              <a:buChar char="•"/>
            </a:pP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x aneuploidy (N = 651)</a:t>
            </a:r>
          </a:p>
          <a:p>
            <a:pPr marL="139303" indent="-139303">
              <a:buFont typeface="Arial" panose="020B0604020202020204" pitchFamily="34" charset="0"/>
              <a:buChar char="•"/>
            </a:pP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ship relatedness (N = 129,107)</a:t>
            </a:r>
          </a:p>
          <a:p>
            <a:pPr marL="139303" indent="-139303">
              <a:buFont typeface="Arial" panose="020B0604020202020204" pitchFamily="34" charset="0"/>
              <a:buChar char="•"/>
            </a:pPr>
            <a:r>
              <a:rPr lang="en-US" altLang="ko-KR" sz="894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n-European British background samples (N = 1,115)</a:t>
            </a:r>
          </a:p>
        </p:txBody>
      </p:sp>
      <p:cxnSp>
        <p:nvCxnSpPr>
          <p:cNvPr id="19" name="직선 화살표 연결선 18"/>
          <p:cNvCxnSpPr/>
          <p:nvPr/>
        </p:nvCxnSpPr>
        <p:spPr>
          <a:xfrm flipV="1">
            <a:off x="2710802" y="1694024"/>
            <a:ext cx="819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3531317" y="1149387"/>
            <a:ext cx="2252250" cy="2299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9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 criteria for samples</a:t>
            </a:r>
            <a:endParaRPr lang="ko-KR" altLang="en-US" sz="89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직선 화살표 연결선 21"/>
          <p:cNvCxnSpPr/>
          <p:nvPr/>
        </p:nvCxnSpPr>
        <p:spPr>
          <a:xfrm flipV="1">
            <a:off x="2710802" y="4531234"/>
            <a:ext cx="819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직선 화살표 연결선 22"/>
          <p:cNvCxnSpPr/>
          <p:nvPr/>
        </p:nvCxnSpPr>
        <p:spPr>
          <a:xfrm flipV="1">
            <a:off x="2710802" y="3253153"/>
            <a:ext cx="819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직선 화살표 연결선 23"/>
          <p:cNvCxnSpPr/>
          <p:nvPr/>
        </p:nvCxnSpPr>
        <p:spPr>
          <a:xfrm flipV="1">
            <a:off x="2710802" y="2356221"/>
            <a:ext cx="819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1" y="381000"/>
            <a:ext cx="7681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endParaRPr lang="ko-KR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56007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2628004" y="906567"/>
            <a:ext cx="1620000" cy="432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ast Asian samples</a:t>
            </a:r>
          </a:p>
          <a:p>
            <a:pPr algn="ctr"/>
            <a:r>
              <a:rPr lang="en-US" altLang="ko-KR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 </a:t>
            </a: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 58,700)</a:t>
            </a:r>
          </a:p>
        </p:txBody>
      </p:sp>
      <p:sp>
        <p:nvSpPr>
          <p:cNvPr id="3" name="직사각형 2"/>
          <p:cNvSpPr/>
          <p:nvPr/>
        </p:nvSpPr>
        <p:spPr>
          <a:xfrm>
            <a:off x="2628004" y="1869654"/>
            <a:ext cx="1620000" cy="432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ast Asian samples</a:t>
            </a:r>
          </a:p>
          <a:p>
            <a:pPr algn="ctr"/>
            <a:r>
              <a:rPr lang="en-US" altLang="ko-KR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 </a:t>
            </a: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 47,257)</a:t>
            </a:r>
          </a:p>
        </p:txBody>
      </p:sp>
      <p:cxnSp>
        <p:nvCxnSpPr>
          <p:cNvPr id="4" name="직선 화살표 연결선 3"/>
          <p:cNvCxnSpPr>
            <a:stCxn id="2" idx="2"/>
            <a:endCxn id="3" idx="0"/>
          </p:cNvCxnSpPr>
          <p:nvPr/>
        </p:nvCxnSpPr>
        <p:spPr>
          <a:xfrm>
            <a:off x="3438004" y="1338568"/>
            <a:ext cx="0" cy="53108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직사각형 5"/>
          <p:cNvSpPr/>
          <p:nvPr/>
        </p:nvSpPr>
        <p:spPr>
          <a:xfrm>
            <a:off x="4475032" y="998890"/>
            <a:ext cx="2160000" cy="1260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 Missing value:</a:t>
            </a:r>
          </a:p>
          <a:p>
            <a:pPr indent="-216000">
              <a:buAutoNum type="arabicPeriod"/>
            </a:pP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ronic bronchitis </a:t>
            </a:r>
            <a:r>
              <a:rPr lang="en-US" altLang="ko-KR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 </a:t>
            </a: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 6,522)</a:t>
            </a:r>
          </a:p>
          <a:p>
            <a:pPr indent="-216000">
              <a:buAutoNum type="arabicPeriod"/>
            </a:pP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PD </a:t>
            </a:r>
            <a:r>
              <a:rPr lang="en-US" altLang="ko-KR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 </a:t>
            </a: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 </a:t>
            </a:r>
            <a:r>
              <a:rPr lang="en-US" altLang="ko-KR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,858</a:t>
            </a: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pPr indent="-216000">
              <a:buAutoNum type="arabicPeriod"/>
            </a:pP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thma </a:t>
            </a:r>
            <a:r>
              <a:rPr lang="en-US" altLang="ko-KR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 </a:t>
            </a: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 5)</a:t>
            </a:r>
          </a:p>
          <a:p>
            <a:pPr indent="-216000">
              <a:buAutoNum type="arabicPeriod"/>
            </a:pP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nset age asthma </a:t>
            </a:r>
            <a:r>
              <a:rPr lang="en-US" altLang="ko-KR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 </a:t>
            </a: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 50)</a:t>
            </a:r>
          </a:p>
          <a:p>
            <a:pPr indent="-216000">
              <a:buAutoNum type="arabicPeriod"/>
            </a:pP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lergic disease </a:t>
            </a:r>
            <a:r>
              <a:rPr lang="en-US" altLang="ko-KR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 </a:t>
            </a: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 8)</a:t>
            </a:r>
          </a:p>
        </p:txBody>
      </p:sp>
      <p:cxnSp>
        <p:nvCxnSpPr>
          <p:cNvPr id="7" name="직선 연결선 6"/>
          <p:cNvCxnSpPr/>
          <p:nvPr/>
        </p:nvCxnSpPr>
        <p:spPr>
          <a:xfrm>
            <a:off x="3438004" y="2311509"/>
            <a:ext cx="0" cy="216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직사각형 9"/>
          <p:cNvSpPr/>
          <p:nvPr/>
        </p:nvSpPr>
        <p:spPr>
          <a:xfrm>
            <a:off x="1913984" y="2763788"/>
            <a:ext cx="1224000" cy="432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  <a:p>
            <a:pPr algn="ctr"/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 = 46,489)</a:t>
            </a:r>
          </a:p>
        </p:txBody>
      </p:sp>
      <p:sp>
        <p:nvSpPr>
          <p:cNvPr id="11" name="직사각형 10"/>
          <p:cNvSpPr/>
          <p:nvPr/>
        </p:nvSpPr>
        <p:spPr>
          <a:xfrm>
            <a:off x="3721505" y="2763792"/>
            <a:ext cx="1224000" cy="432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thma case</a:t>
            </a:r>
          </a:p>
          <a:p>
            <a:pPr algn="ctr"/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 = 768)</a:t>
            </a:r>
          </a:p>
        </p:txBody>
      </p:sp>
      <p:cxnSp>
        <p:nvCxnSpPr>
          <p:cNvPr id="12" name="직선 화살표 연결선 11"/>
          <p:cNvCxnSpPr>
            <a:stCxn id="10" idx="2"/>
            <a:endCxn id="13" idx="0"/>
          </p:cNvCxnSpPr>
          <p:nvPr/>
        </p:nvCxnSpPr>
        <p:spPr>
          <a:xfrm>
            <a:off x="2525984" y="3195789"/>
            <a:ext cx="0" cy="110172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직사각형 12"/>
          <p:cNvSpPr/>
          <p:nvPr/>
        </p:nvSpPr>
        <p:spPr>
          <a:xfrm>
            <a:off x="1913984" y="4297513"/>
            <a:ext cx="1224000" cy="432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  <a:p>
            <a:pPr algn="ctr"/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 =43,062) </a:t>
            </a:r>
          </a:p>
        </p:txBody>
      </p:sp>
      <p:sp>
        <p:nvSpPr>
          <p:cNvPr id="15" name="직사각형 14"/>
          <p:cNvSpPr/>
          <p:nvPr/>
        </p:nvSpPr>
        <p:spPr>
          <a:xfrm>
            <a:off x="75365" y="3297555"/>
            <a:ext cx="1980000" cy="864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 case group</a:t>
            </a:r>
          </a:p>
          <a:p>
            <a:pPr marL="12600" indent="-216000">
              <a:buAutoNum type="arabicPeriod"/>
            </a:pP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PD (N = 73)</a:t>
            </a:r>
          </a:p>
          <a:p>
            <a:pPr marL="12600" indent="-216000">
              <a:buAutoNum type="arabicPeriod"/>
            </a:pP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ronic bronchitis (N = 261)</a:t>
            </a:r>
          </a:p>
          <a:p>
            <a:pPr marL="12600" indent="-216000">
              <a:buAutoNum type="arabicPeriod"/>
            </a:pP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lergic disease (N = 3,093)</a:t>
            </a:r>
          </a:p>
        </p:txBody>
      </p:sp>
      <p:cxnSp>
        <p:nvCxnSpPr>
          <p:cNvPr id="16" name="직선 화살표 연결선 15"/>
          <p:cNvCxnSpPr>
            <a:stCxn id="11" idx="2"/>
            <a:endCxn id="17" idx="0"/>
          </p:cNvCxnSpPr>
          <p:nvPr/>
        </p:nvCxnSpPr>
        <p:spPr>
          <a:xfrm>
            <a:off x="4333505" y="3195793"/>
            <a:ext cx="0" cy="110172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직사각형 16"/>
          <p:cNvSpPr/>
          <p:nvPr/>
        </p:nvSpPr>
        <p:spPr>
          <a:xfrm>
            <a:off x="3721505" y="4297517"/>
            <a:ext cx="1224000" cy="432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te-onset asthma</a:t>
            </a:r>
          </a:p>
          <a:p>
            <a:pPr algn="ctr"/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 = 716)</a:t>
            </a:r>
          </a:p>
        </p:txBody>
      </p:sp>
      <p:sp>
        <p:nvSpPr>
          <p:cNvPr id="19" name="직사각형 18"/>
          <p:cNvSpPr/>
          <p:nvPr/>
        </p:nvSpPr>
        <p:spPr>
          <a:xfrm>
            <a:off x="4793087" y="3297555"/>
            <a:ext cx="1980000" cy="864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 case group</a:t>
            </a:r>
          </a:p>
          <a:p>
            <a:pPr indent="-216000">
              <a:buAutoNum type="arabicPeriod"/>
            </a:pP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PD (N = 11)</a:t>
            </a:r>
          </a:p>
          <a:p>
            <a:pPr indent="-216000">
              <a:buAutoNum type="arabicPeriod"/>
            </a:pP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thma samples developed </a:t>
            </a:r>
          </a:p>
          <a:p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&lt; 16 years (N = 41)</a:t>
            </a:r>
          </a:p>
        </p:txBody>
      </p:sp>
      <p:cxnSp>
        <p:nvCxnSpPr>
          <p:cNvPr id="20" name="직선 연결선 19"/>
          <p:cNvCxnSpPr/>
          <p:nvPr/>
        </p:nvCxnSpPr>
        <p:spPr>
          <a:xfrm>
            <a:off x="2525209" y="4720622"/>
            <a:ext cx="0" cy="252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 20"/>
          <p:cNvCxnSpPr/>
          <p:nvPr/>
        </p:nvCxnSpPr>
        <p:spPr>
          <a:xfrm>
            <a:off x="4332730" y="4720622"/>
            <a:ext cx="0" cy="252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직선 연결선 21"/>
          <p:cNvCxnSpPr/>
          <p:nvPr/>
        </p:nvCxnSpPr>
        <p:spPr>
          <a:xfrm>
            <a:off x="2512781" y="4986884"/>
            <a:ext cx="1825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직선 화살표 연결선 25"/>
          <p:cNvCxnSpPr/>
          <p:nvPr/>
        </p:nvCxnSpPr>
        <p:spPr>
          <a:xfrm>
            <a:off x="3438004" y="4975706"/>
            <a:ext cx="0" cy="154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직사각형 26"/>
          <p:cNvSpPr/>
          <p:nvPr/>
        </p:nvSpPr>
        <p:spPr>
          <a:xfrm>
            <a:off x="2394004" y="6522530"/>
            <a:ext cx="2088000" cy="504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te–onset asthma (N = 603) vs. Control (N = 36,857)</a:t>
            </a:r>
          </a:p>
        </p:txBody>
      </p:sp>
      <p:sp>
        <p:nvSpPr>
          <p:cNvPr id="29" name="직사각형 28"/>
          <p:cNvSpPr/>
          <p:nvPr/>
        </p:nvSpPr>
        <p:spPr>
          <a:xfrm>
            <a:off x="3826681" y="5081652"/>
            <a:ext cx="2988000" cy="1368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 missing values of environmental factors</a:t>
            </a:r>
          </a:p>
          <a:p>
            <a:pPr indent="-216000">
              <a:buAutoNum type="arabicPeriod"/>
            </a:pP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eight, weight (N = 8)</a:t>
            </a:r>
          </a:p>
          <a:p>
            <a:pPr indent="-216000">
              <a:buAutoNum type="arabicPeriod"/>
            </a:pP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moking status (N = 132)</a:t>
            </a:r>
          </a:p>
          <a:p>
            <a:pPr indent="-216000">
              <a:buAutoNum type="arabicPeriod"/>
            </a:pP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WI short form (N =190)</a:t>
            </a:r>
          </a:p>
          <a:p>
            <a:pPr indent="-216000">
              <a:buAutoNum type="arabicPeriod"/>
            </a:pP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come (N = 1,892)</a:t>
            </a:r>
          </a:p>
          <a:p>
            <a:pPr indent="-216000">
              <a:buAutoNum type="arabicPeriod"/>
            </a:pP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cohol intake frequency (N = 3,014)</a:t>
            </a:r>
          </a:p>
          <a:p>
            <a:pPr indent="-216000">
              <a:buAutoNum type="arabicPeriod"/>
            </a:pP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amples &lt; 40 or &gt; 69 years of age (N = 1,082)</a:t>
            </a:r>
          </a:p>
        </p:txBody>
      </p:sp>
      <p:cxnSp>
        <p:nvCxnSpPr>
          <p:cNvPr id="39" name="직선 연결선 38"/>
          <p:cNvCxnSpPr/>
          <p:nvPr/>
        </p:nvCxnSpPr>
        <p:spPr>
          <a:xfrm>
            <a:off x="2512781" y="2520440"/>
            <a:ext cx="18252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직선 화살표 연결선 39"/>
          <p:cNvCxnSpPr/>
          <p:nvPr/>
        </p:nvCxnSpPr>
        <p:spPr>
          <a:xfrm flipV="1">
            <a:off x="3432604" y="1615380"/>
            <a:ext cx="1044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직선 화살표 연결선 40"/>
          <p:cNvCxnSpPr/>
          <p:nvPr/>
        </p:nvCxnSpPr>
        <p:spPr>
          <a:xfrm>
            <a:off x="2525209" y="2509685"/>
            <a:ext cx="0" cy="25200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직선 화살표 연결선 41"/>
          <p:cNvCxnSpPr/>
          <p:nvPr/>
        </p:nvCxnSpPr>
        <p:spPr>
          <a:xfrm>
            <a:off x="4332730" y="2509685"/>
            <a:ext cx="0" cy="25200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직선 화살표 연결선 42"/>
          <p:cNvCxnSpPr/>
          <p:nvPr/>
        </p:nvCxnSpPr>
        <p:spPr>
          <a:xfrm flipV="1">
            <a:off x="4332730" y="3729555"/>
            <a:ext cx="468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직선 화살표 연결선 43"/>
          <p:cNvCxnSpPr/>
          <p:nvPr/>
        </p:nvCxnSpPr>
        <p:spPr>
          <a:xfrm flipV="1">
            <a:off x="2049122" y="3729555"/>
            <a:ext cx="468000" cy="0"/>
          </a:xfrm>
          <a:prstGeom prst="straightConnector1">
            <a:avLst/>
          </a:prstGeom>
          <a:ln w="19050">
            <a:headEnd type="triangle"/>
            <a:tailEnd type="non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직선 화살표 연결선 44"/>
          <p:cNvCxnSpPr/>
          <p:nvPr/>
        </p:nvCxnSpPr>
        <p:spPr>
          <a:xfrm flipV="1">
            <a:off x="3439579" y="5765652"/>
            <a:ext cx="3888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1" y="381000"/>
            <a:ext cx="7681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1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endParaRPr lang="ko-KR" altLang="en-US" sz="11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5529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5084" y="2227095"/>
            <a:ext cx="5507831" cy="486489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0"/>
            <a:ext cx="7681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endParaRPr lang="ko-KR" altLang="en-US" sz="11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16343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89962" y="113788"/>
            <a:ext cx="17355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 smtClean="0"/>
              <a:t>Alcohol intake frequency</a:t>
            </a:r>
            <a:endParaRPr lang="ko-KR" altLang="en-US" sz="11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2138341" y="1463657"/>
            <a:ext cx="4871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/>
              <a:t>BMI</a:t>
            </a:r>
            <a:endParaRPr lang="ko-KR" altLang="en-US" sz="12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626137" y="2895028"/>
            <a:ext cx="9993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/>
              <a:t>Insomnia</a:t>
            </a:r>
            <a:endParaRPr lang="ko-KR" altLang="en-US" sz="1200" b="1" dirty="0"/>
          </a:p>
        </p:txBody>
      </p:sp>
      <p:pic>
        <p:nvPicPr>
          <p:cNvPr id="10" name="그림 9"/>
          <p:cNvPicPr>
            <a:picLocks noChangeAspect="1"/>
          </p:cNvPicPr>
          <p:nvPr/>
        </p:nvPicPr>
        <p:blipFill rotWithShape="1">
          <a:blip r:embed="rId3"/>
          <a:srcRect t="17812"/>
          <a:stretch/>
        </p:blipFill>
        <p:spPr>
          <a:xfrm>
            <a:off x="2571476" y="72192"/>
            <a:ext cx="4282811" cy="1372906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 rotWithShape="1">
          <a:blip r:embed="rId4"/>
          <a:srcRect t="18603"/>
          <a:stretch/>
        </p:blipFill>
        <p:spPr>
          <a:xfrm>
            <a:off x="2571476" y="1488993"/>
            <a:ext cx="4282811" cy="1359698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 rotWithShape="1">
          <a:blip r:embed="rId5"/>
          <a:srcRect t="18364"/>
          <a:stretch/>
        </p:blipFill>
        <p:spPr>
          <a:xfrm>
            <a:off x="2571476" y="2892586"/>
            <a:ext cx="4282811" cy="1363690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 rotWithShape="1">
          <a:blip r:embed="rId6"/>
          <a:srcRect t="17677"/>
          <a:stretch/>
        </p:blipFill>
        <p:spPr>
          <a:xfrm>
            <a:off x="2571476" y="4300171"/>
            <a:ext cx="4282811" cy="1375174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716987" y="4353982"/>
            <a:ext cx="9085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/>
              <a:t>MET score</a:t>
            </a:r>
            <a:endParaRPr lang="ko-KR" altLang="en-US" sz="1200" b="1" dirty="0"/>
          </a:p>
        </p:txBody>
      </p:sp>
      <p:pic>
        <p:nvPicPr>
          <p:cNvPr id="15" name="그림 14"/>
          <p:cNvPicPr>
            <a:picLocks noChangeAspect="1"/>
          </p:cNvPicPr>
          <p:nvPr/>
        </p:nvPicPr>
        <p:blipFill rotWithShape="1">
          <a:blip r:embed="rId7"/>
          <a:srcRect t="18025"/>
          <a:stretch/>
        </p:blipFill>
        <p:spPr>
          <a:xfrm>
            <a:off x="2571476" y="5719240"/>
            <a:ext cx="4282811" cy="1369351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1016023" y="5782911"/>
            <a:ext cx="16094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/>
              <a:t>Neuroticism score</a:t>
            </a:r>
            <a:endParaRPr lang="ko-KR" altLang="en-US" sz="1400" b="1" dirty="0"/>
          </a:p>
        </p:txBody>
      </p:sp>
      <p:pic>
        <p:nvPicPr>
          <p:cNvPr id="17" name="그림 16"/>
          <p:cNvPicPr>
            <a:picLocks noChangeAspect="1"/>
          </p:cNvPicPr>
          <p:nvPr/>
        </p:nvPicPr>
        <p:blipFill rotWithShape="1">
          <a:blip r:embed="rId8"/>
          <a:srcRect t="18251"/>
          <a:stretch/>
        </p:blipFill>
        <p:spPr>
          <a:xfrm>
            <a:off x="2571476" y="7132486"/>
            <a:ext cx="4282811" cy="1365576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855077" y="7228933"/>
            <a:ext cx="1770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/>
              <a:t>Time spent watching TV</a:t>
            </a:r>
            <a:endParaRPr lang="ko-KR" altLang="en-US" sz="1200" b="1" dirty="0"/>
          </a:p>
        </p:txBody>
      </p:sp>
      <p:pic>
        <p:nvPicPr>
          <p:cNvPr id="19" name="그림 18"/>
          <p:cNvPicPr>
            <a:picLocks noChangeAspect="1"/>
          </p:cNvPicPr>
          <p:nvPr/>
        </p:nvPicPr>
        <p:blipFill rotWithShape="1">
          <a:blip r:embed="rId9"/>
          <a:srcRect t="18673"/>
          <a:stretch/>
        </p:blipFill>
        <p:spPr>
          <a:xfrm>
            <a:off x="2571476" y="8541960"/>
            <a:ext cx="4282811" cy="1358530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2159283" y="8539799"/>
            <a:ext cx="466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/>
              <a:t>TDI</a:t>
            </a:r>
            <a:endParaRPr lang="ko-KR" altLang="en-US" sz="12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0" y="0"/>
            <a:ext cx="7681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endParaRPr lang="ko-KR" altLang="en-US" sz="11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7402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61</TotalTime>
  <Words>506</Words>
  <Application>Microsoft Office PowerPoint</Application>
  <PresentationFormat>A4 용지(210x297mm)</PresentationFormat>
  <Paragraphs>89</Paragraphs>
  <Slides>6</Slides>
  <Notes>2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2" baseType="lpstr">
      <vt:lpstr>맑은 고딕</vt:lpstr>
      <vt:lpstr>Arial</vt:lpstr>
      <vt:lpstr>Calibri</vt:lpstr>
      <vt:lpstr>Calibri Light</vt:lpstr>
      <vt:lpstr>Times New Roman</vt:lpstr>
      <vt:lpstr>Office 테마</vt:lpstr>
      <vt:lpstr>Supplementary figures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백은주</dc:creator>
  <cp:lastModifiedBy>user</cp:lastModifiedBy>
  <cp:revision>71</cp:revision>
  <cp:lastPrinted>2022-01-20T07:44:48Z</cp:lastPrinted>
  <dcterms:created xsi:type="dcterms:W3CDTF">2022-01-18T05:39:30Z</dcterms:created>
  <dcterms:modified xsi:type="dcterms:W3CDTF">2022-01-27T06:45:46Z</dcterms:modified>
</cp:coreProperties>
</file>